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670675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70F9E1-720A-40DE-9E76-DC2401EB11C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58D37C-EF24-4CB6-A0F8-03A7A17A76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F97910-72C0-4929-A0FA-E5FAFD34434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0C930B-FB44-4022-9CC0-6D58294487B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75016E-1945-4C43-B959-BCB3FE3029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C3C59D-49E8-4A50-87EF-D41753825E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38FF04-1BAE-430F-B9C8-7BEE22FB2C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7DDC79-2DA2-49A8-A3CB-A5416973AA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0C9904-81F0-47D3-B06B-BC2491CDDE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58A19A-8A1E-49D3-8651-AD457FFDFA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23016B-5922-4DDF-ADC8-EFBED943EA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7A28F2-E66C-454F-B4E7-B08031A61F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424C8DE-FD6B-4E0A-803A-F92E5D09939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ieren 211"/>
          <p:cNvGrpSpPr/>
          <p:nvPr/>
        </p:nvGrpSpPr>
        <p:grpSpPr>
          <a:xfrm>
            <a:off x="3568680" y="1735200"/>
            <a:ext cx="725400" cy="723960"/>
            <a:chOff x="3568680" y="1735200"/>
            <a:chExt cx="725400" cy="723960"/>
          </a:xfrm>
        </p:grpSpPr>
        <p:sp>
          <p:nvSpPr>
            <p:cNvPr id="42" name="Freeform 193"/>
            <p:cNvSpPr/>
            <p:nvPr/>
          </p:nvSpPr>
          <p:spPr>
            <a:xfrm>
              <a:off x="3930480" y="1735200"/>
              <a:ext cx="363600" cy="698760"/>
            </a:xfrm>
            <a:custGeom>
              <a:avLst/>
              <a:gdLst/>
              <a:ahLst/>
              <a:rect l="l" t="t" r="r" b="b"/>
              <a:pathLst>
                <a:path w="685" h="1320">
                  <a:moveTo>
                    <a:pt x="0" y="684"/>
                  </a:moveTo>
                  <a:lnTo>
                    <a:pt x="251" y="1320"/>
                  </a:lnTo>
                  <a:lnTo>
                    <a:pt x="285" y="1306"/>
                  </a:lnTo>
                  <a:lnTo>
                    <a:pt x="315" y="1291"/>
                  </a:lnTo>
                  <a:lnTo>
                    <a:pt x="346" y="1274"/>
                  </a:lnTo>
                  <a:lnTo>
                    <a:pt x="375" y="1256"/>
                  </a:lnTo>
                  <a:lnTo>
                    <a:pt x="429" y="1216"/>
                  </a:lnTo>
                  <a:lnTo>
                    <a:pt x="480" y="1172"/>
                  </a:lnTo>
                  <a:lnTo>
                    <a:pt x="525" y="1123"/>
                  </a:lnTo>
                  <a:lnTo>
                    <a:pt x="566" y="1070"/>
                  </a:lnTo>
                  <a:lnTo>
                    <a:pt x="582" y="1044"/>
                  </a:lnTo>
                  <a:lnTo>
                    <a:pt x="599" y="1015"/>
                  </a:lnTo>
                  <a:lnTo>
                    <a:pt x="614" y="986"/>
                  </a:lnTo>
                  <a:lnTo>
                    <a:pt x="628" y="956"/>
                  </a:lnTo>
                  <a:lnTo>
                    <a:pt x="641" y="926"/>
                  </a:lnTo>
                  <a:lnTo>
                    <a:pt x="652" y="894"/>
                  </a:lnTo>
                  <a:lnTo>
                    <a:pt x="662" y="863"/>
                  </a:lnTo>
                  <a:lnTo>
                    <a:pt x="669" y="831"/>
                  </a:lnTo>
                  <a:lnTo>
                    <a:pt x="676" y="798"/>
                  </a:lnTo>
                  <a:lnTo>
                    <a:pt x="680" y="766"/>
                  </a:lnTo>
                  <a:lnTo>
                    <a:pt x="684" y="733"/>
                  </a:lnTo>
                  <a:lnTo>
                    <a:pt x="685" y="699"/>
                  </a:lnTo>
                  <a:lnTo>
                    <a:pt x="685" y="666"/>
                  </a:lnTo>
                  <a:lnTo>
                    <a:pt x="683" y="633"/>
                  </a:lnTo>
                  <a:lnTo>
                    <a:pt x="680" y="599"/>
                  </a:lnTo>
                  <a:lnTo>
                    <a:pt x="674" y="566"/>
                  </a:lnTo>
                  <a:lnTo>
                    <a:pt x="667" y="531"/>
                  </a:lnTo>
                  <a:lnTo>
                    <a:pt x="659" y="498"/>
                  </a:lnTo>
                  <a:lnTo>
                    <a:pt x="649" y="465"/>
                  </a:lnTo>
                  <a:lnTo>
                    <a:pt x="637" y="433"/>
                  </a:lnTo>
                  <a:lnTo>
                    <a:pt x="616" y="384"/>
                  </a:lnTo>
                  <a:lnTo>
                    <a:pt x="591" y="338"/>
                  </a:lnTo>
                  <a:lnTo>
                    <a:pt x="564" y="295"/>
                  </a:lnTo>
                  <a:lnTo>
                    <a:pt x="534" y="255"/>
                  </a:lnTo>
                  <a:lnTo>
                    <a:pt x="500" y="216"/>
                  </a:lnTo>
                  <a:lnTo>
                    <a:pt x="464" y="180"/>
                  </a:lnTo>
                  <a:lnTo>
                    <a:pt x="425" y="148"/>
                  </a:lnTo>
                  <a:lnTo>
                    <a:pt x="385" y="118"/>
                  </a:lnTo>
                  <a:lnTo>
                    <a:pt x="342" y="91"/>
                  </a:lnTo>
                  <a:lnTo>
                    <a:pt x="297" y="68"/>
                  </a:lnTo>
                  <a:lnTo>
                    <a:pt x="251" y="48"/>
                  </a:lnTo>
                  <a:lnTo>
                    <a:pt x="203" y="30"/>
                  </a:lnTo>
                  <a:lnTo>
                    <a:pt x="154" y="18"/>
                  </a:lnTo>
                  <a:lnTo>
                    <a:pt x="104" y="8"/>
                  </a:lnTo>
                  <a:lnTo>
                    <a:pt x="53" y="2"/>
                  </a:lnTo>
                  <a:lnTo>
                    <a:pt x="0" y="0"/>
                  </a:lnTo>
                  <a:lnTo>
                    <a:pt x="0" y="684"/>
                  </a:lnTo>
                  <a:close/>
                </a:path>
              </a:pathLst>
            </a:custGeom>
            <a:solidFill>
              <a:srgbClr val="ff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Freeform 194"/>
            <p:cNvSpPr/>
            <p:nvPr/>
          </p:nvSpPr>
          <p:spPr>
            <a:xfrm>
              <a:off x="3568680" y="2006640"/>
              <a:ext cx="495360" cy="452520"/>
            </a:xfrm>
            <a:custGeom>
              <a:avLst/>
              <a:gdLst/>
              <a:ahLst/>
              <a:rect l="l" t="t" r="r" b="b"/>
              <a:pathLst>
                <a:path w="937" h="856">
                  <a:moveTo>
                    <a:pt x="686" y="171"/>
                  </a:moveTo>
                  <a:lnTo>
                    <a:pt x="22" y="0"/>
                  </a:lnTo>
                  <a:lnTo>
                    <a:pt x="14" y="35"/>
                  </a:lnTo>
                  <a:lnTo>
                    <a:pt x="9" y="70"/>
                  </a:lnTo>
                  <a:lnTo>
                    <a:pt x="4" y="103"/>
                  </a:lnTo>
                  <a:lnTo>
                    <a:pt x="2" y="138"/>
                  </a:lnTo>
                  <a:lnTo>
                    <a:pt x="0" y="173"/>
                  </a:lnTo>
                  <a:lnTo>
                    <a:pt x="2" y="206"/>
                  </a:lnTo>
                  <a:lnTo>
                    <a:pt x="4" y="239"/>
                  </a:lnTo>
                  <a:lnTo>
                    <a:pt x="9" y="273"/>
                  </a:lnTo>
                  <a:lnTo>
                    <a:pt x="14" y="305"/>
                  </a:lnTo>
                  <a:lnTo>
                    <a:pt x="21" y="338"/>
                  </a:lnTo>
                  <a:lnTo>
                    <a:pt x="29" y="370"/>
                  </a:lnTo>
                  <a:lnTo>
                    <a:pt x="41" y="400"/>
                  </a:lnTo>
                  <a:lnTo>
                    <a:pt x="52" y="431"/>
                  </a:lnTo>
                  <a:lnTo>
                    <a:pt x="66" y="461"/>
                  </a:lnTo>
                  <a:lnTo>
                    <a:pt x="80" y="491"/>
                  </a:lnTo>
                  <a:lnTo>
                    <a:pt x="96" y="520"/>
                  </a:lnTo>
                  <a:lnTo>
                    <a:pt x="132" y="574"/>
                  </a:lnTo>
                  <a:lnTo>
                    <a:pt x="174" y="625"/>
                  </a:lnTo>
                  <a:lnTo>
                    <a:pt x="220" y="673"/>
                  </a:lnTo>
                  <a:lnTo>
                    <a:pt x="270" y="716"/>
                  </a:lnTo>
                  <a:lnTo>
                    <a:pt x="326" y="753"/>
                  </a:lnTo>
                  <a:lnTo>
                    <a:pt x="355" y="771"/>
                  </a:lnTo>
                  <a:lnTo>
                    <a:pt x="385" y="786"/>
                  </a:lnTo>
                  <a:lnTo>
                    <a:pt x="416" y="800"/>
                  </a:lnTo>
                  <a:lnTo>
                    <a:pt x="448" y="813"/>
                  </a:lnTo>
                  <a:lnTo>
                    <a:pt x="481" y="824"/>
                  </a:lnTo>
                  <a:lnTo>
                    <a:pt x="516" y="834"/>
                  </a:lnTo>
                  <a:lnTo>
                    <a:pt x="569" y="845"/>
                  </a:lnTo>
                  <a:lnTo>
                    <a:pt x="622" y="852"/>
                  </a:lnTo>
                  <a:lnTo>
                    <a:pt x="675" y="856"/>
                  </a:lnTo>
                  <a:lnTo>
                    <a:pt x="729" y="854"/>
                  </a:lnTo>
                  <a:lnTo>
                    <a:pt x="782" y="849"/>
                  </a:lnTo>
                  <a:lnTo>
                    <a:pt x="835" y="839"/>
                  </a:lnTo>
                  <a:lnTo>
                    <a:pt x="887" y="825"/>
                  </a:lnTo>
                  <a:lnTo>
                    <a:pt x="937" y="807"/>
                  </a:lnTo>
                  <a:lnTo>
                    <a:pt x="686" y="171"/>
                  </a:lnTo>
                  <a:close/>
                </a:path>
              </a:pathLst>
            </a:custGeom>
            <a:solidFill>
              <a:srgbClr val="0066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Freeform 195"/>
            <p:cNvSpPr/>
            <p:nvPr/>
          </p:nvSpPr>
          <p:spPr>
            <a:xfrm>
              <a:off x="3579480" y="1746000"/>
              <a:ext cx="350640" cy="351000"/>
            </a:xfrm>
            <a:custGeom>
              <a:avLst/>
              <a:gdLst/>
              <a:ahLst/>
              <a:rect l="l" t="t" r="r" b="b"/>
              <a:pathLst>
                <a:path w="664" h="662">
                  <a:moveTo>
                    <a:pt x="664" y="662"/>
                  </a:moveTo>
                  <a:lnTo>
                    <a:pt x="494" y="0"/>
                  </a:lnTo>
                  <a:lnTo>
                    <a:pt x="448" y="12"/>
                  </a:lnTo>
                  <a:lnTo>
                    <a:pt x="405" y="29"/>
                  </a:lnTo>
                  <a:lnTo>
                    <a:pt x="363" y="47"/>
                  </a:lnTo>
                  <a:lnTo>
                    <a:pt x="323" y="69"/>
                  </a:lnTo>
                  <a:lnTo>
                    <a:pt x="284" y="93"/>
                  </a:lnTo>
                  <a:lnTo>
                    <a:pt x="248" y="119"/>
                  </a:lnTo>
                  <a:lnTo>
                    <a:pt x="212" y="147"/>
                  </a:lnTo>
                  <a:lnTo>
                    <a:pt x="180" y="179"/>
                  </a:lnTo>
                  <a:lnTo>
                    <a:pt x="148" y="211"/>
                  </a:lnTo>
                  <a:lnTo>
                    <a:pt x="120" y="246"/>
                  </a:lnTo>
                  <a:lnTo>
                    <a:pt x="94" y="283"/>
                  </a:lnTo>
                  <a:lnTo>
                    <a:pt x="70" y="322"/>
                  </a:lnTo>
                  <a:lnTo>
                    <a:pt x="48" y="362"/>
                  </a:lnTo>
                  <a:lnTo>
                    <a:pt x="30" y="404"/>
                  </a:lnTo>
                  <a:lnTo>
                    <a:pt x="13" y="447"/>
                  </a:lnTo>
                  <a:lnTo>
                    <a:pt x="0" y="491"/>
                  </a:lnTo>
                  <a:lnTo>
                    <a:pt x="664" y="662"/>
                  </a:lnTo>
                  <a:close/>
                </a:path>
              </a:pathLst>
            </a:custGeom>
            <a:solidFill>
              <a:srgbClr val="0070c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Freeform 196"/>
            <p:cNvSpPr/>
            <p:nvPr/>
          </p:nvSpPr>
          <p:spPr>
            <a:xfrm>
              <a:off x="3841560" y="1735200"/>
              <a:ext cx="88920" cy="362160"/>
            </a:xfrm>
            <a:custGeom>
              <a:avLst/>
              <a:gdLst/>
              <a:ahLst/>
              <a:rect l="l" t="t" r="r" b="b"/>
              <a:pathLst>
                <a:path w="170" h="684">
                  <a:moveTo>
                    <a:pt x="170" y="684"/>
                  </a:moveTo>
                  <a:lnTo>
                    <a:pt x="170" y="0"/>
                  </a:lnTo>
                  <a:lnTo>
                    <a:pt x="127" y="1"/>
                  </a:lnTo>
                  <a:lnTo>
                    <a:pt x="84" y="5"/>
                  </a:lnTo>
                  <a:lnTo>
                    <a:pt x="42" y="12"/>
                  </a:lnTo>
                  <a:lnTo>
                    <a:pt x="0" y="22"/>
                  </a:lnTo>
                  <a:lnTo>
                    <a:pt x="170" y="684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6" name="Gruppieren 212"/>
          <p:cNvGrpSpPr/>
          <p:nvPr/>
        </p:nvGrpSpPr>
        <p:grpSpPr>
          <a:xfrm>
            <a:off x="3570120" y="2562120"/>
            <a:ext cx="729000" cy="728640"/>
            <a:chOff x="3570120" y="2562120"/>
            <a:chExt cx="729000" cy="728640"/>
          </a:xfrm>
        </p:grpSpPr>
        <p:sp>
          <p:nvSpPr>
            <p:cNvPr id="47" name="Freeform 210"/>
            <p:cNvSpPr/>
            <p:nvPr/>
          </p:nvSpPr>
          <p:spPr>
            <a:xfrm>
              <a:off x="3935520" y="2562120"/>
              <a:ext cx="363600" cy="527040"/>
            </a:xfrm>
            <a:custGeom>
              <a:avLst/>
              <a:gdLst/>
              <a:ahLst/>
              <a:rect l="l" t="t" r="r" b="b"/>
              <a:pathLst>
                <a:path w="689" h="997">
                  <a:moveTo>
                    <a:pt x="0" y="690"/>
                  </a:moveTo>
                  <a:lnTo>
                    <a:pt x="618" y="997"/>
                  </a:lnTo>
                  <a:lnTo>
                    <a:pt x="633" y="965"/>
                  </a:lnTo>
                  <a:lnTo>
                    <a:pt x="646" y="931"/>
                  </a:lnTo>
                  <a:lnTo>
                    <a:pt x="657" y="899"/>
                  </a:lnTo>
                  <a:lnTo>
                    <a:pt x="668" y="866"/>
                  </a:lnTo>
                  <a:lnTo>
                    <a:pt x="675" y="832"/>
                  </a:lnTo>
                  <a:lnTo>
                    <a:pt x="681" y="799"/>
                  </a:lnTo>
                  <a:lnTo>
                    <a:pt x="685" y="765"/>
                  </a:lnTo>
                  <a:lnTo>
                    <a:pt x="688" y="732"/>
                  </a:lnTo>
                  <a:lnTo>
                    <a:pt x="689" y="698"/>
                  </a:lnTo>
                  <a:lnTo>
                    <a:pt x="689" y="665"/>
                  </a:lnTo>
                  <a:lnTo>
                    <a:pt x="687" y="631"/>
                  </a:lnTo>
                  <a:lnTo>
                    <a:pt x="684" y="598"/>
                  </a:lnTo>
                  <a:lnTo>
                    <a:pt x="678" y="566"/>
                  </a:lnTo>
                  <a:lnTo>
                    <a:pt x="672" y="532"/>
                  </a:lnTo>
                  <a:lnTo>
                    <a:pt x="663" y="500"/>
                  </a:lnTo>
                  <a:lnTo>
                    <a:pt x="653" y="470"/>
                  </a:lnTo>
                  <a:lnTo>
                    <a:pt x="643" y="438"/>
                  </a:lnTo>
                  <a:lnTo>
                    <a:pt x="630" y="407"/>
                  </a:lnTo>
                  <a:lnTo>
                    <a:pt x="615" y="378"/>
                  </a:lnTo>
                  <a:lnTo>
                    <a:pt x="599" y="349"/>
                  </a:lnTo>
                  <a:lnTo>
                    <a:pt x="564" y="292"/>
                  </a:lnTo>
                  <a:lnTo>
                    <a:pt x="522" y="240"/>
                  </a:lnTo>
                  <a:lnTo>
                    <a:pt x="476" y="190"/>
                  </a:lnTo>
                  <a:lnTo>
                    <a:pt x="425" y="147"/>
                  </a:lnTo>
                  <a:lnTo>
                    <a:pt x="368" y="106"/>
                  </a:lnTo>
                  <a:lnTo>
                    <a:pt x="307" y="73"/>
                  </a:lnTo>
                  <a:lnTo>
                    <a:pt x="271" y="55"/>
                  </a:lnTo>
                  <a:lnTo>
                    <a:pt x="233" y="41"/>
                  </a:lnTo>
                  <a:lnTo>
                    <a:pt x="197" y="29"/>
                  </a:lnTo>
                  <a:lnTo>
                    <a:pt x="157" y="19"/>
                  </a:lnTo>
                  <a:lnTo>
                    <a:pt x="120" y="10"/>
                  </a:lnTo>
                  <a:lnTo>
                    <a:pt x="80" y="4"/>
                  </a:lnTo>
                  <a:lnTo>
                    <a:pt x="40" y="1"/>
                  </a:lnTo>
                  <a:lnTo>
                    <a:pt x="0" y="0"/>
                  </a:lnTo>
                  <a:lnTo>
                    <a:pt x="0" y="690"/>
                  </a:lnTo>
                  <a:close/>
                </a:path>
              </a:pathLst>
            </a:custGeom>
            <a:solidFill>
              <a:srgbClr val="ff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Freeform 211"/>
            <p:cNvSpPr/>
            <p:nvPr/>
          </p:nvSpPr>
          <p:spPr>
            <a:xfrm>
              <a:off x="3574800" y="2927160"/>
              <a:ext cx="687960" cy="363600"/>
            </a:xfrm>
            <a:custGeom>
              <a:avLst/>
              <a:gdLst/>
              <a:ahLst/>
              <a:rect l="l" t="t" r="r" b="b"/>
              <a:pathLst>
                <a:path w="1299" h="689">
                  <a:moveTo>
                    <a:pt x="681" y="0"/>
                  </a:moveTo>
                  <a:lnTo>
                    <a:pt x="0" y="98"/>
                  </a:lnTo>
                  <a:lnTo>
                    <a:pt x="5" y="133"/>
                  </a:lnTo>
                  <a:lnTo>
                    <a:pt x="13" y="167"/>
                  </a:lnTo>
                  <a:lnTo>
                    <a:pt x="23" y="200"/>
                  </a:lnTo>
                  <a:lnTo>
                    <a:pt x="33" y="234"/>
                  </a:lnTo>
                  <a:lnTo>
                    <a:pt x="46" y="266"/>
                  </a:lnTo>
                  <a:lnTo>
                    <a:pt x="59" y="296"/>
                  </a:lnTo>
                  <a:lnTo>
                    <a:pt x="91" y="356"/>
                  </a:lnTo>
                  <a:lnTo>
                    <a:pt x="129" y="411"/>
                  </a:lnTo>
                  <a:lnTo>
                    <a:pt x="171" y="462"/>
                  </a:lnTo>
                  <a:lnTo>
                    <a:pt x="218" y="510"/>
                  </a:lnTo>
                  <a:lnTo>
                    <a:pt x="269" y="552"/>
                  </a:lnTo>
                  <a:lnTo>
                    <a:pt x="324" y="589"/>
                  </a:lnTo>
                  <a:lnTo>
                    <a:pt x="382" y="621"/>
                  </a:lnTo>
                  <a:lnTo>
                    <a:pt x="412" y="634"/>
                  </a:lnTo>
                  <a:lnTo>
                    <a:pt x="443" y="647"/>
                  </a:lnTo>
                  <a:lnTo>
                    <a:pt x="475" y="657"/>
                  </a:lnTo>
                  <a:lnTo>
                    <a:pt x="507" y="667"/>
                  </a:lnTo>
                  <a:lnTo>
                    <a:pt x="539" y="675"/>
                  </a:lnTo>
                  <a:lnTo>
                    <a:pt x="572" y="680"/>
                  </a:lnTo>
                  <a:lnTo>
                    <a:pt x="606" y="685"/>
                  </a:lnTo>
                  <a:lnTo>
                    <a:pt x="641" y="688"/>
                  </a:lnTo>
                  <a:lnTo>
                    <a:pt x="674" y="689"/>
                  </a:lnTo>
                  <a:lnTo>
                    <a:pt x="709" y="689"/>
                  </a:lnTo>
                  <a:lnTo>
                    <a:pt x="744" y="686"/>
                  </a:lnTo>
                  <a:lnTo>
                    <a:pt x="780" y="682"/>
                  </a:lnTo>
                  <a:lnTo>
                    <a:pt x="821" y="675"/>
                  </a:lnTo>
                  <a:lnTo>
                    <a:pt x="862" y="666"/>
                  </a:lnTo>
                  <a:lnTo>
                    <a:pt x="902" y="653"/>
                  </a:lnTo>
                  <a:lnTo>
                    <a:pt x="942" y="638"/>
                  </a:lnTo>
                  <a:lnTo>
                    <a:pt x="979" y="622"/>
                  </a:lnTo>
                  <a:lnTo>
                    <a:pt x="1016" y="603"/>
                  </a:lnTo>
                  <a:lnTo>
                    <a:pt x="1052" y="582"/>
                  </a:lnTo>
                  <a:lnTo>
                    <a:pt x="1086" y="558"/>
                  </a:lnTo>
                  <a:lnTo>
                    <a:pt x="1119" y="534"/>
                  </a:lnTo>
                  <a:lnTo>
                    <a:pt x="1150" y="506"/>
                  </a:lnTo>
                  <a:lnTo>
                    <a:pt x="1179" y="477"/>
                  </a:lnTo>
                  <a:lnTo>
                    <a:pt x="1208" y="446"/>
                  </a:lnTo>
                  <a:lnTo>
                    <a:pt x="1232" y="414"/>
                  </a:lnTo>
                  <a:lnTo>
                    <a:pt x="1257" y="379"/>
                  </a:lnTo>
                  <a:lnTo>
                    <a:pt x="1279" y="343"/>
                  </a:lnTo>
                  <a:lnTo>
                    <a:pt x="1299" y="307"/>
                  </a:lnTo>
                  <a:lnTo>
                    <a:pt x="681" y="0"/>
                  </a:lnTo>
                  <a:close/>
                </a:path>
              </a:pathLst>
            </a:custGeom>
            <a:solidFill>
              <a:srgbClr val="0066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Freeform 212"/>
            <p:cNvSpPr/>
            <p:nvPr/>
          </p:nvSpPr>
          <p:spPr>
            <a:xfrm>
              <a:off x="3570120" y="2607840"/>
              <a:ext cx="365400" cy="369720"/>
            </a:xfrm>
            <a:custGeom>
              <a:avLst/>
              <a:gdLst/>
              <a:ahLst/>
              <a:rect l="l" t="t" r="r" b="b"/>
              <a:pathLst>
                <a:path w="689" h="701">
                  <a:moveTo>
                    <a:pt x="689" y="603"/>
                  </a:moveTo>
                  <a:lnTo>
                    <a:pt x="355" y="0"/>
                  </a:lnTo>
                  <a:lnTo>
                    <a:pt x="309" y="28"/>
                  </a:lnTo>
                  <a:lnTo>
                    <a:pt x="266" y="58"/>
                  </a:lnTo>
                  <a:lnTo>
                    <a:pt x="227" y="92"/>
                  </a:lnTo>
                  <a:lnTo>
                    <a:pt x="189" y="128"/>
                  </a:lnTo>
                  <a:lnTo>
                    <a:pt x="156" y="167"/>
                  </a:lnTo>
                  <a:lnTo>
                    <a:pt x="124" y="208"/>
                  </a:lnTo>
                  <a:lnTo>
                    <a:pt x="96" y="252"/>
                  </a:lnTo>
                  <a:lnTo>
                    <a:pt x="73" y="297"/>
                  </a:lnTo>
                  <a:lnTo>
                    <a:pt x="51" y="343"/>
                  </a:lnTo>
                  <a:lnTo>
                    <a:pt x="34" y="392"/>
                  </a:lnTo>
                  <a:lnTo>
                    <a:pt x="19" y="441"/>
                  </a:lnTo>
                  <a:lnTo>
                    <a:pt x="9" y="492"/>
                  </a:lnTo>
                  <a:lnTo>
                    <a:pt x="3" y="543"/>
                  </a:lnTo>
                  <a:lnTo>
                    <a:pt x="0" y="595"/>
                  </a:lnTo>
                  <a:lnTo>
                    <a:pt x="2" y="648"/>
                  </a:lnTo>
                  <a:lnTo>
                    <a:pt x="8" y="701"/>
                  </a:lnTo>
                  <a:lnTo>
                    <a:pt x="689" y="603"/>
                  </a:lnTo>
                  <a:close/>
                </a:path>
              </a:pathLst>
            </a:custGeom>
            <a:solidFill>
              <a:srgbClr val="0070c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Freeform 213"/>
            <p:cNvSpPr/>
            <p:nvPr/>
          </p:nvSpPr>
          <p:spPr>
            <a:xfrm>
              <a:off x="3757320" y="2562120"/>
              <a:ext cx="177840" cy="365040"/>
            </a:xfrm>
            <a:custGeom>
              <a:avLst/>
              <a:gdLst/>
              <a:ahLst/>
              <a:rect l="l" t="t" r="r" b="b"/>
              <a:pathLst>
                <a:path w="334" h="690">
                  <a:moveTo>
                    <a:pt x="334" y="690"/>
                  </a:moveTo>
                  <a:lnTo>
                    <a:pt x="334" y="0"/>
                  </a:lnTo>
                  <a:lnTo>
                    <a:pt x="291" y="1"/>
                  </a:lnTo>
                  <a:lnTo>
                    <a:pt x="247" y="6"/>
                  </a:lnTo>
                  <a:lnTo>
                    <a:pt x="204" y="13"/>
                  </a:lnTo>
                  <a:lnTo>
                    <a:pt x="161" y="22"/>
                  </a:lnTo>
                  <a:lnTo>
                    <a:pt x="119" y="35"/>
                  </a:lnTo>
                  <a:lnTo>
                    <a:pt x="79" y="49"/>
                  </a:lnTo>
                  <a:lnTo>
                    <a:pt x="39" y="67"/>
                  </a:lnTo>
                  <a:lnTo>
                    <a:pt x="0" y="87"/>
                  </a:lnTo>
                  <a:lnTo>
                    <a:pt x="334" y="69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1" name="Gruppieren 213"/>
          <p:cNvGrpSpPr/>
          <p:nvPr/>
        </p:nvGrpSpPr>
        <p:grpSpPr>
          <a:xfrm>
            <a:off x="3571920" y="3397320"/>
            <a:ext cx="718920" cy="717120"/>
            <a:chOff x="3571920" y="3397320"/>
            <a:chExt cx="718920" cy="717120"/>
          </a:xfrm>
        </p:grpSpPr>
        <p:sp>
          <p:nvSpPr>
            <p:cNvPr id="52" name="Freeform 227"/>
            <p:cNvSpPr/>
            <p:nvPr/>
          </p:nvSpPr>
          <p:spPr>
            <a:xfrm>
              <a:off x="3932280" y="3397320"/>
              <a:ext cx="358560" cy="604800"/>
            </a:xfrm>
            <a:custGeom>
              <a:avLst/>
              <a:gdLst/>
              <a:ahLst/>
              <a:rect l="l" t="t" r="r" b="b"/>
              <a:pathLst>
                <a:path w="904" h="1521">
                  <a:moveTo>
                    <a:pt x="0" y="904"/>
                  </a:moveTo>
                  <a:lnTo>
                    <a:pt x="659" y="1521"/>
                  </a:lnTo>
                  <a:lnTo>
                    <a:pt x="690" y="1487"/>
                  </a:lnTo>
                  <a:lnTo>
                    <a:pt x="719" y="1451"/>
                  </a:lnTo>
                  <a:lnTo>
                    <a:pt x="745" y="1414"/>
                  </a:lnTo>
                  <a:lnTo>
                    <a:pt x="771" y="1376"/>
                  </a:lnTo>
                  <a:lnTo>
                    <a:pt x="793" y="1337"/>
                  </a:lnTo>
                  <a:lnTo>
                    <a:pt x="813" y="1298"/>
                  </a:lnTo>
                  <a:lnTo>
                    <a:pt x="831" y="1258"/>
                  </a:lnTo>
                  <a:lnTo>
                    <a:pt x="848" y="1216"/>
                  </a:lnTo>
                  <a:lnTo>
                    <a:pt x="863" y="1175"/>
                  </a:lnTo>
                  <a:lnTo>
                    <a:pt x="875" y="1133"/>
                  </a:lnTo>
                  <a:lnTo>
                    <a:pt x="885" y="1090"/>
                  </a:lnTo>
                  <a:lnTo>
                    <a:pt x="893" y="1048"/>
                  </a:lnTo>
                  <a:lnTo>
                    <a:pt x="899" y="1005"/>
                  </a:lnTo>
                  <a:lnTo>
                    <a:pt x="902" y="962"/>
                  </a:lnTo>
                  <a:lnTo>
                    <a:pt x="904" y="918"/>
                  </a:lnTo>
                  <a:lnTo>
                    <a:pt x="904" y="875"/>
                  </a:lnTo>
                  <a:lnTo>
                    <a:pt x="902" y="832"/>
                  </a:lnTo>
                  <a:lnTo>
                    <a:pt x="897" y="789"/>
                  </a:lnTo>
                  <a:lnTo>
                    <a:pt x="891" y="746"/>
                  </a:lnTo>
                  <a:lnTo>
                    <a:pt x="882" y="703"/>
                  </a:lnTo>
                  <a:lnTo>
                    <a:pt x="872" y="661"/>
                  </a:lnTo>
                  <a:lnTo>
                    <a:pt x="858" y="619"/>
                  </a:lnTo>
                  <a:lnTo>
                    <a:pt x="844" y="577"/>
                  </a:lnTo>
                  <a:lnTo>
                    <a:pt x="827" y="537"/>
                  </a:lnTo>
                  <a:lnTo>
                    <a:pt x="808" y="497"/>
                  </a:lnTo>
                  <a:lnTo>
                    <a:pt x="787" y="458"/>
                  </a:lnTo>
                  <a:lnTo>
                    <a:pt x="764" y="420"/>
                  </a:lnTo>
                  <a:lnTo>
                    <a:pt x="740" y="383"/>
                  </a:lnTo>
                  <a:lnTo>
                    <a:pt x="712" y="346"/>
                  </a:lnTo>
                  <a:lnTo>
                    <a:pt x="682" y="312"/>
                  </a:lnTo>
                  <a:lnTo>
                    <a:pt x="652" y="278"/>
                  </a:lnTo>
                  <a:lnTo>
                    <a:pt x="619" y="245"/>
                  </a:lnTo>
                  <a:lnTo>
                    <a:pt x="586" y="217"/>
                  </a:lnTo>
                  <a:lnTo>
                    <a:pt x="554" y="190"/>
                  </a:lnTo>
                  <a:lnTo>
                    <a:pt x="519" y="164"/>
                  </a:lnTo>
                  <a:lnTo>
                    <a:pt x="483" y="141"/>
                  </a:lnTo>
                  <a:lnTo>
                    <a:pt x="447" y="118"/>
                  </a:lnTo>
                  <a:lnTo>
                    <a:pt x="409" y="98"/>
                  </a:lnTo>
                  <a:lnTo>
                    <a:pt x="371" y="80"/>
                  </a:lnTo>
                  <a:lnTo>
                    <a:pt x="332" y="64"/>
                  </a:lnTo>
                  <a:lnTo>
                    <a:pt x="293" y="49"/>
                  </a:lnTo>
                  <a:lnTo>
                    <a:pt x="253" y="37"/>
                  </a:lnTo>
                  <a:lnTo>
                    <a:pt x="211" y="26"/>
                  </a:lnTo>
                  <a:lnTo>
                    <a:pt x="170" y="17"/>
                  </a:lnTo>
                  <a:lnTo>
                    <a:pt x="127" y="10"/>
                  </a:lnTo>
                  <a:lnTo>
                    <a:pt x="85" y="4"/>
                  </a:lnTo>
                  <a:lnTo>
                    <a:pt x="42" y="1"/>
                  </a:lnTo>
                  <a:lnTo>
                    <a:pt x="0" y="0"/>
                  </a:lnTo>
                  <a:lnTo>
                    <a:pt x="0" y="904"/>
                  </a:lnTo>
                  <a:close/>
                </a:path>
              </a:pathLst>
            </a:custGeom>
            <a:solidFill>
              <a:srgbClr val="ff99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Freeform 228"/>
            <p:cNvSpPr/>
            <p:nvPr/>
          </p:nvSpPr>
          <p:spPr>
            <a:xfrm>
              <a:off x="3584520" y="3755880"/>
              <a:ext cx="609480" cy="358560"/>
            </a:xfrm>
            <a:custGeom>
              <a:avLst/>
              <a:gdLst/>
              <a:ahLst/>
              <a:rect l="l" t="t" r="r" b="b"/>
              <a:pathLst>
                <a:path w="1536" h="902">
                  <a:moveTo>
                    <a:pt x="877" y="0"/>
                  </a:moveTo>
                  <a:lnTo>
                    <a:pt x="0" y="224"/>
                  </a:lnTo>
                  <a:lnTo>
                    <a:pt x="12" y="269"/>
                  </a:lnTo>
                  <a:lnTo>
                    <a:pt x="27" y="312"/>
                  </a:lnTo>
                  <a:lnTo>
                    <a:pt x="44" y="355"/>
                  </a:lnTo>
                  <a:lnTo>
                    <a:pt x="63" y="395"/>
                  </a:lnTo>
                  <a:lnTo>
                    <a:pt x="84" y="435"/>
                  </a:lnTo>
                  <a:lnTo>
                    <a:pt x="106" y="473"/>
                  </a:lnTo>
                  <a:lnTo>
                    <a:pt x="130" y="511"/>
                  </a:lnTo>
                  <a:lnTo>
                    <a:pt x="157" y="547"/>
                  </a:lnTo>
                  <a:lnTo>
                    <a:pt x="184" y="580"/>
                  </a:lnTo>
                  <a:lnTo>
                    <a:pt x="213" y="614"/>
                  </a:lnTo>
                  <a:lnTo>
                    <a:pt x="243" y="644"/>
                  </a:lnTo>
                  <a:lnTo>
                    <a:pt x="275" y="674"/>
                  </a:lnTo>
                  <a:lnTo>
                    <a:pt x="309" y="702"/>
                  </a:lnTo>
                  <a:lnTo>
                    <a:pt x="343" y="729"/>
                  </a:lnTo>
                  <a:lnTo>
                    <a:pt x="378" y="753"/>
                  </a:lnTo>
                  <a:lnTo>
                    <a:pt x="415" y="776"/>
                  </a:lnTo>
                  <a:lnTo>
                    <a:pt x="453" y="797"/>
                  </a:lnTo>
                  <a:lnTo>
                    <a:pt x="493" y="817"/>
                  </a:lnTo>
                  <a:lnTo>
                    <a:pt x="532" y="834"/>
                  </a:lnTo>
                  <a:lnTo>
                    <a:pt x="573" y="850"/>
                  </a:lnTo>
                  <a:lnTo>
                    <a:pt x="615" y="863"/>
                  </a:lnTo>
                  <a:lnTo>
                    <a:pt x="656" y="875"/>
                  </a:lnTo>
                  <a:lnTo>
                    <a:pt x="699" y="884"/>
                  </a:lnTo>
                  <a:lnTo>
                    <a:pt x="742" y="892"/>
                  </a:lnTo>
                  <a:lnTo>
                    <a:pt x="786" y="898"/>
                  </a:lnTo>
                  <a:lnTo>
                    <a:pt x="831" y="901"/>
                  </a:lnTo>
                  <a:lnTo>
                    <a:pt x="875" y="902"/>
                  </a:lnTo>
                  <a:lnTo>
                    <a:pt x="920" y="901"/>
                  </a:lnTo>
                  <a:lnTo>
                    <a:pt x="965" y="898"/>
                  </a:lnTo>
                  <a:lnTo>
                    <a:pt x="1011" y="892"/>
                  </a:lnTo>
                  <a:lnTo>
                    <a:pt x="1056" y="884"/>
                  </a:lnTo>
                  <a:lnTo>
                    <a:pt x="1102" y="873"/>
                  </a:lnTo>
                  <a:lnTo>
                    <a:pt x="1163" y="855"/>
                  </a:lnTo>
                  <a:lnTo>
                    <a:pt x="1222" y="833"/>
                  </a:lnTo>
                  <a:lnTo>
                    <a:pt x="1281" y="807"/>
                  </a:lnTo>
                  <a:lnTo>
                    <a:pt x="1337" y="776"/>
                  </a:lnTo>
                  <a:lnTo>
                    <a:pt x="1390" y="742"/>
                  </a:lnTo>
                  <a:lnTo>
                    <a:pt x="1442" y="704"/>
                  </a:lnTo>
                  <a:lnTo>
                    <a:pt x="1490" y="662"/>
                  </a:lnTo>
                  <a:lnTo>
                    <a:pt x="1536" y="617"/>
                  </a:lnTo>
                  <a:lnTo>
                    <a:pt x="877" y="0"/>
                  </a:lnTo>
                  <a:close/>
                </a:path>
              </a:pathLst>
            </a:custGeom>
            <a:solidFill>
              <a:srgbClr val="0066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Freeform 229"/>
            <p:cNvSpPr/>
            <p:nvPr/>
          </p:nvSpPr>
          <p:spPr>
            <a:xfrm>
              <a:off x="3571920" y="3432240"/>
              <a:ext cx="360360" cy="412560"/>
            </a:xfrm>
            <a:custGeom>
              <a:avLst/>
              <a:gdLst/>
              <a:ahLst/>
              <a:rect l="l" t="t" r="r" b="b"/>
              <a:pathLst>
                <a:path w="906" h="1042">
                  <a:moveTo>
                    <a:pt x="906" y="818"/>
                  </a:moveTo>
                  <a:lnTo>
                    <a:pt x="519" y="0"/>
                  </a:lnTo>
                  <a:lnTo>
                    <a:pt x="484" y="18"/>
                  </a:lnTo>
                  <a:lnTo>
                    <a:pt x="449" y="38"/>
                  </a:lnTo>
                  <a:lnTo>
                    <a:pt x="414" y="58"/>
                  </a:lnTo>
                  <a:lnTo>
                    <a:pt x="382" y="80"/>
                  </a:lnTo>
                  <a:lnTo>
                    <a:pt x="350" y="104"/>
                  </a:lnTo>
                  <a:lnTo>
                    <a:pt x="319" y="128"/>
                  </a:lnTo>
                  <a:lnTo>
                    <a:pt x="290" y="155"/>
                  </a:lnTo>
                  <a:lnTo>
                    <a:pt x="262" y="182"/>
                  </a:lnTo>
                  <a:lnTo>
                    <a:pt x="235" y="210"/>
                  </a:lnTo>
                  <a:lnTo>
                    <a:pt x="210" y="239"/>
                  </a:lnTo>
                  <a:lnTo>
                    <a:pt x="186" y="269"/>
                  </a:lnTo>
                  <a:lnTo>
                    <a:pt x="163" y="300"/>
                  </a:lnTo>
                  <a:lnTo>
                    <a:pt x="142" y="332"/>
                  </a:lnTo>
                  <a:lnTo>
                    <a:pt x="122" y="365"/>
                  </a:lnTo>
                  <a:lnTo>
                    <a:pt x="104" y="399"/>
                  </a:lnTo>
                  <a:lnTo>
                    <a:pt x="86" y="432"/>
                  </a:lnTo>
                  <a:lnTo>
                    <a:pt x="70" y="468"/>
                  </a:lnTo>
                  <a:lnTo>
                    <a:pt x="57" y="504"/>
                  </a:lnTo>
                  <a:lnTo>
                    <a:pt x="44" y="539"/>
                  </a:lnTo>
                  <a:lnTo>
                    <a:pt x="34" y="576"/>
                  </a:lnTo>
                  <a:lnTo>
                    <a:pt x="23" y="613"/>
                  </a:lnTo>
                  <a:lnTo>
                    <a:pt x="16" y="651"/>
                  </a:lnTo>
                  <a:lnTo>
                    <a:pt x="9" y="689"/>
                  </a:lnTo>
                  <a:lnTo>
                    <a:pt x="4" y="728"/>
                  </a:lnTo>
                  <a:lnTo>
                    <a:pt x="1" y="766"/>
                  </a:lnTo>
                  <a:lnTo>
                    <a:pt x="0" y="805"/>
                  </a:lnTo>
                  <a:lnTo>
                    <a:pt x="1" y="844"/>
                  </a:lnTo>
                  <a:lnTo>
                    <a:pt x="2" y="883"/>
                  </a:lnTo>
                  <a:lnTo>
                    <a:pt x="7" y="924"/>
                  </a:lnTo>
                  <a:lnTo>
                    <a:pt x="12" y="963"/>
                  </a:lnTo>
                  <a:lnTo>
                    <a:pt x="19" y="1002"/>
                  </a:lnTo>
                  <a:lnTo>
                    <a:pt x="29" y="1042"/>
                  </a:lnTo>
                  <a:lnTo>
                    <a:pt x="906" y="818"/>
                  </a:lnTo>
                  <a:close/>
                </a:path>
              </a:pathLst>
            </a:custGeom>
            <a:solidFill>
              <a:srgbClr val="0070c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Freeform 230"/>
            <p:cNvSpPr/>
            <p:nvPr/>
          </p:nvSpPr>
          <p:spPr>
            <a:xfrm>
              <a:off x="3778200" y="3397320"/>
              <a:ext cx="153720" cy="358560"/>
            </a:xfrm>
            <a:custGeom>
              <a:avLst/>
              <a:gdLst/>
              <a:ahLst/>
              <a:rect l="l" t="t" r="r" b="b"/>
              <a:pathLst>
                <a:path w="387" h="904">
                  <a:moveTo>
                    <a:pt x="387" y="904"/>
                  </a:moveTo>
                  <a:lnTo>
                    <a:pt x="387" y="0"/>
                  </a:lnTo>
                  <a:lnTo>
                    <a:pt x="336" y="1"/>
                  </a:lnTo>
                  <a:lnTo>
                    <a:pt x="287" y="6"/>
                  </a:lnTo>
                  <a:lnTo>
                    <a:pt x="238" y="12"/>
                  </a:lnTo>
                  <a:lnTo>
                    <a:pt x="188" y="22"/>
                  </a:lnTo>
                  <a:lnTo>
                    <a:pt x="140" y="35"/>
                  </a:lnTo>
                  <a:lnTo>
                    <a:pt x="93" y="49"/>
                  </a:lnTo>
                  <a:lnTo>
                    <a:pt x="46" y="66"/>
                  </a:lnTo>
                  <a:lnTo>
                    <a:pt x="0" y="86"/>
                  </a:lnTo>
                  <a:lnTo>
                    <a:pt x="387" y="904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6" name="Text Box 231"/>
          <p:cNvSpPr/>
          <p:nvPr/>
        </p:nvSpPr>
        <p:spPr>
          <a:xfrm>
            <a:off x="2392560" y="5168880"/>
            <a:ext cx="76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Fig.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724"/>
          <p:cNvSpPr/>
          <p:nvPr/>
        </p:nvSpPr>
        <p:spPr>
          <a:xfrm>
            <a:off x="2533680" y="1673280"/>
            <a:ext cx="1703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standar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725"/>
          <p:cNvSpPr/>
          <p:nvPr/>
        </p:nvSpPr>
        <p:spPr>
          <a:xfrm>
            <a:off x="2533680" y="2525760"/>
            <a:ext cx="176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enriche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726"/>
          <p:cNvSpPr/>
          <p:nvPr/>
        </p:nvSpPr>
        <p:spPr>
          <a:xfrm>
            <a:off x="2533680" y="3359160"/>
            <a:ext cx="1763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reachin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0" name="Group 131"/>
          <p:cNvGrpSpPr/>
          <p:nvPr/>
        </p:nvGrpSpPr>
        <p:grpSpPr>
          <a:xfrm>
            <a:off x="2398680" y="4354560"/>
            <a:ext cx="1328760" cy="587160"/>
            <a:chOff x="2398680" y="4354560"/>
            <a:chExt cx="1328760" cy="587160"/>
          </a:xfrm>
        </p:grpSpPr>
        <p:sp>
          <p:nvSpPr>
            <p:cNvPr id="61" name="Text Box 620"/>
            <p:cNvSpPr/>
            <p:nvPr/>
          </p:nvSpPr>
          <p:spPr>
            <a:xfrm>
              <a:off x="2399040" y="4726080"/>
              <a:ext cx="1110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BrdU+ NG2- GST</a:t>
              </a:r>
              <a:r>
                <a:rPr b="1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π</a:t>
              </a: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621"/>
            <p:cNvSpPr/>
            <p:nvPr/>
          </p:nvSpPr>
          <p:spPr>
            <a:xfrm>
              <a:off x="2399040" y="4602240"/>
              <a:ext cx="1136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BrdU+ NG2- GST</a:t>
              </a:r>
              <a:r>
                <a:rPr b="1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π</a:t>
              </a: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623"/>
            <p:cNvSpPr/>
            <p:nvPr/>
          </p:nvSpPr>
          <p:spPr>
            <a:xfrm>
              <a:off x="2398680" y="4478400"/>
              <a:ext cx="1133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BrdU+ NG2+GST</a:t>
              </a:r>
              <a:r>
                <a:rPr b="1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π</a:t>
              </a: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 Box 626"/>
            <p:cNvSpPr/>
            <p:nvPr/>
          </p:nvSpPr>
          <p:spPr>
            <a:xfrm>
              <a:off x="2399040" y="4354560"/>
              <a:ext cx="1107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BrdU+ NG2+GST</a:t>
              </a:r>
              <a:r>
                <a:rPr b="1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π</a:t>
              </a: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684"/>
            <p:cNvSpPr/>
            <p:nvPr/>
          </p:nvSpPr>
          <p:spPr>
            <a:xfrm>
              <a:off x="3484800" y="4430880"/>
              <a:ext cx="242640" cy="63360"/>
            </a:xfrm>
            <a:prstGeom prst="rect">
              <a:avLst/>
            </a:prstGeom>
            <a:solidFill>
              <a:srgbClr val="ff99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6560" bIns="165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685"/>
            <p:cNvSpPr/>
            <p:nvPr/>
          </p:nvSpPr>
          <p:spPr>
            <a:xfrm>
              <a:off x="3484800" y="4552920"/>
              <a:ext cx="242640" cy="65160"/>
            </a:xfrm>
            <a:prstGeom prst="rect">
              <a:avLst/>
            </a:prstGeom>
            <a:solidFill>
              <a:srgbClr val="008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8360" bIns="183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687"/>
            <p:cNvSpPr/>
            <p:nvPr/>
          </p:nvSpPr>
          <p:spPr>
            <a:xfrm>
              <a:off x="3484800" y="4676760"/>
              <a:ext cx="242640" cy="65160"/>
            </a:xfrm>
            <a:prstGeom prst="rect">
              <a:avLst/>
            </a:prstGeom>
            <a:solidFill>
              <a:srgbClr val="007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8360" bIns="183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687"/>
            <p:cNvSpPr/>
            <p:nvPr/>
          </p:nvSpPr>
          <p:spPr>
            <a:xfrm>
              <a:off x="3484800" y="4800600"/>
              <a:ext cx="242640" cy="651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8360" bIns="183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9" name="Text Box 799"/>
          <p:cNvSpPr/>
          <p:nvPr/>
        </p:nvSpPr>
        <p:spPr>
          <a:xfrm>
            <a:off x="3529080" y="1449360"/>
            <a:ext cx="81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42 day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800"/>
          <p:cNvSpPr/>
          <p:nvPr/>
        </p:nvSpPr>
        <p:spPr>
          <a:xfrm>
            <a:off x="2471760" y="1449360"/>
            <a:ext cx="772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10 day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740"/>
          <p:cNvSpPr/>
          <p:nvPr/>
        </p:nvSpPr>
        <p:spPr>
          <a:xfrm>
            <a:off x="3616920" y="2136600"/>
            <a:ext cx="392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35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  <a:ea typeface="Arial"/>
              </a:rPr>
              <a:t>±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3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741"/>
          <p:cNvSpPr/>
          <p:nvPr/>
        </p:nvSpPr>
        <p:spPr>
          <a:xfrm>
            <a:off x="3927240" y="2727360"/>
            <a:ext cx="392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23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  <a:ea typeface="Arial"/>
              </a:rPr>
              <a:t>±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1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742"/>
          <p:cNvSpPr/>
          <p:nvPr/>
        </p:nvSpPr>
        <p:spPr>
          <a:xfrm>
            <a:off x="3728880" y="3892680"/>
            <a:ext cx="392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34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  <a:ea typeface="Arial"/>
              </a:rPr>
              <a:t>±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2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746"/>
          <p:cNvSpPr/>
          <p:nvPr/>
        </p:nvSpPr>
        <p:spPr>
          <a:xfrm rot="935400">
            <a:off x="3595320" y="1843200"/>
            <a:ext cx="3499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Arial"/>
              </a:rPr>
              <a:t>17</a:t>
            </a:r>
            <a:r>
              <a:rPr b="0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±</a:t>
            </a:r>
            <a:r>
              <a:rPr b="0" lang="de-DE" sz="6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747"/>
          <p:cNvSpPr/>
          <p:nvPr/>
        </p:nvSpPr>
        <p:spPr>
          <a:xfrm rot="3766200">
            <a:off x="3709440" y="2582640"/>
            <a:ext cx="307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Arial"/>
              </a:rPr>
              <a:t>8</a:t>
            </a:r>
            <a:r>
              <a:rPr b="0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±</a:t>
            </a:r>
            <a:r>
              <a:rPr b="0" lang="de-DE" sz="6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748"/>
          <p:cNvSpPr/>
          <p:nvPr/>
        </p:nvSpPr>
        <p:spPr>
          <a:xfrm rot="3753600">
            <a:off x="3691800" y="3412800"/>
            <a:ext cx="3499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Arial"/>
              </a:rPr>
              <a:t>7</a:t>
            </a:r>
            <a:r>
              <a:rPr b="0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±</a:t>
            </a:r>
            <a:r>
              <a:rPr b="0" lang="de-DE" sz="6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752"/>
          <p:cNvSpPr/>
          <p:nvPr/>
        </p:nvSpPr>
        <p:spPr>
          <a:xfrm rot="4369200">
            <a:off x="3745440" y="1732320"/>
            <a:ext cx="307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Arial"/>
              </a:rPr>
              <a:t>4</a:t>
            </a:r>
            <a:r>
              <a:rPr b="0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±</a:t>
            </a:r>
            <a:r>
              <a:rPr b="0" lang="de-DE" sz="6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753"/>
          <p:cNvSpPr/>
          <p:nvPr/>
        </p:nvSpPr>
        <p:spPr>
          <a:xfrm rot="1056600">
            <a:off x="3558600" y="2749320"/>
            <a:ext cx="392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Arial"/>
              </a:rPr>
              <a:t>19</a:t>
            </a:r>
            <a:r>
              <a:rPr b="0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±</a:t>
            </a:r>
            <a:r>
              <a:rPr b="0" lang="de-DE" sz="6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754"/>
          <p:cNvSpPr/>
          <p:nvPr/>
        </p:nvSpPr>
        <p:spPr>
          <a:xfrm rot="1191000">
            <a:off x="3550680" y="3574800"/>
            <a:ext cx="392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Arial"/>
              </a:rPr>
              <a:t>22</a:t>
            </a:r>
            <a:r>
              <a:rPr b="0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±</a:t>
            </a:r>
            <a:r>
              <a:rPr b="0" lang="de-DE" sz="6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758"/>
          <p:cNvSpPr/>
          <p:nvPr/>
        </p:nvSpPr>
        <p:spPr>
          <a:xfrm>
            <a:off x="3927960" y="1947960"/>
            <a:ext cx="392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44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  <a:ea typeface="Arial"/>
              </a:rPr>
              <a:t>±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2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759"/>
          <p:cNvSpPr/>
          <p:nvPr/>
        </p:nvSpPr>
        <p:spPr>
          <a:xfrm>
            <a:off x="3761280" y="3036960"/>
            <a:ext cx="392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40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  <a:ea typeface="Arial"/>
              </a:rPr>
              <a:t>±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1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760"/>
          <p:cNvSpPr/>
          <p:nvPr/>
        </p:nvSpPr>
        <p:spPr>
          <a:xfrm>
            <a:off x="3956400" y="3559320"/>
            <a:ext cx="3499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37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  <a:ea typeface="Arial"/>
              </a:rPr>
              <a:t>±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Freeform 156"/>
          <p:cNvSpPr/>
          <p:nvPr/>
        </p:nvSpPr>
        <p:spPr>
          <a:xfrm>
            <a:off x="2862360" y="2579760"/>
            <a:ext cx="365040" cy="706320"/>
          </a:xfrm>
          <a:custGeom>
            <a:avLst/>
            <a:gdLst/>
            <a:ahLst/>
            <a:rect l="l" t="t" r="r" b="b"/>
            <a:pathLst>
              <a:path w="690" h="1333">
                <a:moveTo>
                  <a:pt x="0" y="690"/>
                </a:moveTo>
                <a:lnTo>
                  <a:pt x="254" y="1333"/>
                </a:lnTo>
                <a:lnTo>
                  <a:pt x="286" y="1318"/>
                </a:lnTo>
                <a:lnTo>
                  <a:pt x="318" y="1303"/>
                </a:lnTo>
                <a:lnTo>
                  <a:pt x="349" y="1286"/>
                </a:lnTo>
                <a:lnTo>
                  <a:pt x="378" y="1268"/>
                </a:lnTo>
                <a:lnTo>
                  <a:pt x="406" y="1249"/>
                </a:lnTo>
                <a:lnTo>
                  <a:pt x="433" y="1228"/>
                </a:lnTo>
                <a:lnTo>
                  <a:pt x="459" y="1206"/>
                </a:lnTo>
                <a:lnTo>
                  <a:pt x="484" y="1183"/>
                </a:lnTo>
                <a:lnTo>
                  <a:pt x="506" y="1159"/>
                </a:lnTo>
                <a:lnTo>
                  <a:pt x="529" y="1134"/>
                </a:lnTo>
                <a:lnTo>
                  <a:pt x="550" y="1108"/>
                </a:lnTo>
                <a:lnTo>
                  <a:pt x="569" y="1080"/>
                </a:lnTo>
                <a:lnTo>
                  <a:pt x="588" y="1053"/>
                </a:lnTo>
                <a:lnTo>
                  <a:pt x="604" y="1024"/>
                </a:lnTo>
                <a:lnTo>
                  <a:pt x="619" y="995"/>
                </a:lnTo>
                <a:lnTo>
                  <a:pt x="633" y="965"/>
                </a:lnTo>
                <a:lnTo>
                  <a:pt x="645" y="934"/>
                </a:lnTo>
                <a:lnTo>
                  <a:pt x="656" y="902"/>
                </a:lnTo>
                <a:lnTo>
                  <a:pt x="666" y="871"/>
                </a:lnTo>
                <a:lnTo>
                  <a:pt x="674" y="839"/>
                </a:lnTo>
                <a:lnTo>
                  <a:pt x="680" y="806"/>
                </a:lnTo>
                <a:lnTo>
                  <a:pt x="685" y="772"/>
                </a:lnTo>
                <a:lnTo>
                  <a:pt x="688" y="740"/>
                </a:lnTo>
                <a:lnTo>
                  <a:pt x="690" y="706"/>
                </a:lnTo>
                <a:lnTo>
                  <a:pt x="690" y="672"/>
                </a:lnTo>
                <a:lnTo>
                  <a:pt x="688" y="639"/>
                </a:lnTo>
                <a:lnTo>
                  <a:pt x="685" y="605"/>
                </a:lnTo>
                <a:lnTo>
                  <a:pt x="680" y="571"/>
                </a:lnTo>
                <a:lnTo>
                  <a:pt x="673" y="537"/>
                </a:lnTo>
                <a:lnTo>
                  <a:pt x="664" y="504"/>
                </a:lnTo>
                <a:lnTo>
                  <a:pt x="654" y="470"/>
                </a:lnTo>
                <a:lnTo>
                  <a:pt x="641" y="436"/>
                </a:lnTo>
                <a:lnTo>
                  <a:pt x="620" y="387"/>
                </a:lnTo>
                <a:lnTo>
                  <a:pt x="595" y="342"/>
                </a:lnTo>
                <a:lnTo>
                  <a:pt x="568" y="298"/>
                </a:lnTo>
                <a:lnTo>
                  <a:pt x="536" y="257"/>
                </a:lnTo>
                <a:lnTo>
                  <a:pt x="504" y="218"/>
                </a:lnTo>
                <a:lnTo>
                  <a:pt x="468" y="182"/>
                </a:lnTo>
                <a:lnTo>
                  <a:pt x="429" y="150"/>
                </a:lnTo>
                <a:lnTo>
                  <a:pt x="388" y="120"/>
                </a:lnTo>
                <a:lnTo>
                  <a:pt x="345" y="92"/>
                </a:lnTo>
                <a:lnTo>
                  <a:pt x="300" y="68"/>
                </a:lnTo>
                <a:lnTo>
                  <a:pt x="253" y="48"/>
                </a:lnTo>
                <a:lnTo>
                  <a:pt x="205" y="31"/>
                </a:lnTo>
                <a:lnTo>
                  <a:pt x="155" y="17"/>
                </a:lnTo>
                <a:lnTo>
                  <a:pt x="104" y="8"/>
                </a:lnTo>
                <a:lnTo>
                  <a:pt x="53" y="2"/>
                </a:lnTo>
                <a:lnTo>
                  <a:pt x="0" y="0"/>
                </a:lnTo>
                <a:lnTo>
                  <a:pt x="0" y="690"/>
                </a:lnTo>
                <a:close/>
              </a:path>
            </a:pathLst>
          </a:custGeom>
          <a:solidFill>
            <a:srgbClr val="ff99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Freeform 157"/>
          <p:cNvSpPr/>
          <p:nvPr/>
        </p:nvSpPr>
        <p:spPr>
          <a:xfrm>
            <a:off x="2498760" y="2944800"/>
            <a:ext cx="496800" cy="365040"/>
          </a:xfrm>
          <a:custGeom>
            <a:avLst/>
            <a:gdLst/>
            <a:ahLst/>
            <a:rect l="l" t="t" r="r" b="b"/>
            <a:pathLst>
              <a:path w="944" h="690">
                <a:moveTo>
                  <a:pt x="690" y="0"/>
                </a:moveTo>
                <a:lnTo>
                  <a:pt x="0" y="0"/>
                </a:lnTo>
                <a:lnTo>
                  <a:pt x="0" y="36"/>
                </a:lnTo>
                <a:lnTo>
                  <a:pt x="3" y="71"/>
                </a:lnTo>
                <a:lnTo>
                  <a:pt x="8" y="105"/>
                </a:lnTo>
                <a:lnTo>
                  <a:pt x="14" y="140"/>
                </a:lnTo>
                <a:lnTo>
                  <a:pt x="21" y="172"/>
                </a:lnTo>
                <a:lnTo>
                  <a:pt x="30" y="205"/>
                </a:lnTo>
                <a:lnTo>
                  <a:pt x="41" y="237"/>
                </a:lnTo>
                <a:lnTo>
                  <a:pt x="54" y="269"/>
                </a:lnTo>
                <a:lnTo>
                  <a:pt x="68" y="300"/>
                </a:lnTo>
                <a:lnTo>
                  <a:pt x="83" y="329"/>
                </a:lnTo>
                <a:lnTo>
                  <a:pt x="100" y="359"/>
                </a:lnTo>
                <a:lnTo>
                  <a:pt x="118" y="386"/>
                </a:lnTo>
                <a:lnTo>
                  <a:pt x="136" y="414"/>
                </a:lnTo>
                <a:lnTo>
                  <a:pt x="158" y="439"/>
                </a:lnTo>
                <a:lnTo>
                  <a:pt x="201" y="489"/>
                </a:lnTo>
                <a:lnTo>
                  <a:pt x="251" y="533"/>
                </a:lnTo>
                <a:lnTo>
                  <a:pt x="276" y="554"/>
                </a:lnTo>
                <a:lnTo>
                  <a:pt x="304" y="573"/>
                </a:lnTo>
                <a:lnTo>
                  <a:pt x="331" y="590"/>
                </a:lnTo>
                <a:lnTo>
                  <a:pt x="361" y="608"/>
                </a:lnTo>
                <a:lnTo>
                  <a:pt x="390" y="623"/>
                </a:lnTo>
                <a:lnTo>
                  <a:pt x="421" y="636"/>
                </a:lnTo>
                <a:lnTo>
                  <a:pt x="453" y="649"/>
                </a:lnTo>
                <a:lnTo>
                  <a:pt x="484" y="660"/>
                </a:lnTo>
                <a:lnTo>
                  <a:pt x="518" y="669"/>
                </a:lnTo>
                <a:lnTo>
                  <a:pt x="550" y="676"/>
                </a:lnTo>
                <a:lnTo>
                  <a:pt x="585" y="683"/>
                </a:lnTo>
                <a:lnTo>
                  <a:pt x="619" y="688"/>
                </a:lnTo>
                <a:lnTo>
                  <a:pt x="654" y="690"/>
                </a:lnTo>
                <a:lnTo>
                  <a:pt x="690" y="690"/>
                </a:lnTo>
                <a:lnTo>
                  <a:pt x="723" y="690"/>
                </a:lnTo>
                <a:lnTo>
                  <a:pt x="755" y="688"/>
                </a:lnTo>
                <a:lnTo>
                  <a:pt x="786" y="684"/>
                </a:lnTo>
                <a:lnTo>
                  <a:pt x="819" y="679"/>
                </a:lnTo>
                <a:lnTo>
                  <a:pt x="851" y="671"/>
                </a:lnTo>
                <a:lnTo>
                  <a:pt x="883" y="663"/>
                </a:lnTo>
                <a:lnTo>
                  <a:pt x="913" y="654"/>
                </a:lnTo>
                <a:lnTo>
                  <a:pt x="944" y="643"/>
                </a:lnTo>
                <a:lnTo>
                  <a:pt x="690" y="0"/>
                </a:lnTo>
                <a:close/>
              </a:path>
            </a:pathLst>
          </a:custGeom>
          <a:solidFill>
            <a:srgbClr val="0066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Freeform 158"/>
          <p:cNvSpPr/>
          <p:nvPr/>
        </p:nvSpPr>
        <p:spPr>
          <a:xfrm>
            <a:off x="2498760" y="2679840"/>
            <a:ext cx="363600" cy="264960"/>
          </a:xfrm>
          <a:custGeom>
            <a:avLst/>
            <a:gdLst/>
            <a:ahLst/>
            <a:rect l="l" t="t" r="r" b="b"/>
            <a:pathLst>
              <a:path w="690" h="503">
                <a:moveTo>
                  <a:pt x="690" y="503"/>
                </a:moveTo>
                <a:lnTo>
                  <a:pt x="218" y="0"/>
                </a:lnTo>
                <a:lnTo>
                  <a:pt x="191" y="25"/>
                </a:lnTo>
                <a:lnTo>
                  <a:pt x="168" y="51"/>
                </a:lnTo>
                <a:lnTo>
                  <a:pt x="145" y="79"/>
                </a:lnTo>
                <a:lnTo>
                  <a:pt x="125" y="106"/>
                </a:lnTo>
                <a:lnTo>
                  <a:pt x="105" y="136"/>
                </a:lnTo>
                <a:lnTo>
                  <a:pt x="88" y="166"/>
                </a:lnTo>
                <a:lnTo>
                  <a:pt x="71" y="198"/>
                </a:lnTo>
                <a:lnTo>
                  <a:pt x="56" y="229"/>
                </a:lnTo>
                <a:lnTo>
                  <a:pt x="44" y="262"/>
                </a:lnTo>
                <a:lnTo>
                  <a:pt x="31" y="294"/>
                </a:lnTo>
                <a:lnTo>
                  <a:pt x="23" y="328"/>
                </a:lnTo>
                <a:lnTo>
                  <a:pt x="14" y="363"/>
                </a:lnTo>
                <a:lnTo>
                  <a:pt x="8" y="397"/>
                </a:lnTo>
                <a:lnTo>
                  <a:pt x="4" y="433"/>
                </a:lnTo>
                <a:lnTo>
                  <a:pt x="0" y="468"/>
                </a:lnTo>
                <a:lnTo>
                  <a:pt x="0" y="503"/>
                </a:lnTo>
                <a:lnTo>
                  <a:pt x="690" y="503"/>
                </a:lnTo>
                <a:close/>
              </a:path>
            </a:pathLst>
          </a:custGeom>
          <a:solidFill>
            <a:srgbClr val="0070c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Freeform 159"/>
          <p:cNvSpPr/>
          <p:nvPr/>
        </p:nvSpPr>
        <p:spPr>
          <a:xfrm>
            <a:off x="2612880" y="2579760"/>
            <a:ext cx="249480" cy="365040"/>
          </a:xfrm>
          <a:custGeom>
            <a:avLst/>
            <a:gdLst/>
            <a:ahLst/>
            <a:rect l="l" t="t" r="r" b="b"/>
            <a:pathLst>
              <a:path w="472" h="690">
                <a:moveTo>
                  <a:pt x="472" y="690"/>
                </a:moveTo>
                <a:lnTo>
                  <a:pt x="472" y="0"/>
                </a:lnTo>
                <a:lnTo>
                  <a:pt x="438" y="1"/>
                </a:lnTo>
                <a:lnTo>
                  <a:pt x="406" y="3"/>
                </a:lnTo>
                <a:lnTo>
                  <a:pt x="373" y="7"/>
                </a:lnTo>
                <a:lnTo>
                  <a:pt x="342" y="12"/>
                </a:lnTo>
                <a:lnTo>
                  <a:pt x="310" y="20"/>
                </a:lnTo>
                <a:lnTo>
                  <a:pt x="278" y="27"/>
                </a:lnTo>
                <a:lnTo>
                  <a:pt x="248" y="37"/>
                </a:lnTo>
                <a:lnTo>
                  <a:pt x="217" y="48"/>
                </a:lnTo>
                <a:lnTo>
                  <a:pt x="188" y="61"/>
                </a:lnTo>
                <a:lnTo>
                  <a:pt x="158" y="75"/>
                </a:lnTo>
                <a:lnTo>
                  <a:pt x="130" y="91"/>
                </a:lnTo>
                <a:lnTo>
                  <a:pt x="102" y="107"/>
                </a:lnTo>
                <a:lnTo>
                  <a:pt x="76" y="125"/>
                </a:lnTo>
                <a:lnTo>
                  <a:pt x="50" y="145"/>
                </a:lnTo>
                <a:lnTo>
                  <a:pt x="23" y="165"/>
                </a:lnTo>
                <a:lnTo>
                  <a:pt x="0" y="187"/>
                </a:lnTo>
                <a:lnTo>
                  <a:pt x="472" y="69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737"/>
          <p:cNvSpPr/>
          <p:nvPr/>
        </p:nvSpPr>
        <p:spPr>
          <a:xfrm>
            <a:off x="2851560" y="2847960"/>
            <a:ext cx="392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44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  <a:ea typeface="Arial"/>
              </a:rPr>
              <a:t>±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3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737"/>
          <p:cNvSpPr/>
          <p:nvPr/>
        </p:nvSpPr>
        <p:spPr>
          <a:xfrm>
            <a:off x="2553120" y="3006720"/>
            <a:ext cx="392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31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  <a:ea typeface="Arial"/>
              </a:rPr>
              <a:t>±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1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737"/>
          <p:cNvSpPr/>
          <p:nvPr/>
        </p:nvSpPr>
        <p:spPr>
          <a:xfrm rot="890400">
            <a:off x="2463840" y="2770200"/>
            <a:ext cx="392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Arial"/>
              </a:rPr>
              <a:t>13</a:t>
            </a:r>
            <a:r>
              <a:rPr b="0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±1</a:t>
            </a:r>
            <a:r>
              <a:rPr b="0" lang="de-DE" sz="6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737"/>
          <p:cNvSpPr/>
          <p:nvPr/>
        </p:nvSpPr>
        <p:spPr>
          <a:xfrm rot="2824800">
            <a:off x="2562480" y="2628360"/>
            <a:ext cx="392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Arial"/>
              </a:rPr>
              <a:t>12</a:t>
            </a:r>
            <a:r>
              <a:rPr b="0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±1</a:t>
            </a:r>
            <a:r>
              <a:rPr b="0" lang="de-DE" sz="6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Freeform 173"/>
          <p:cNvSpPr/>
          <p:nvPr/>
        </p:nvSpPr>
        <p:spPr>
          <a:xfrm>
            <a:off x="2521080" y="3403440"/>
            <a:ext cx="703080" cy="723960"/>
          </a:xfrm>
          <a:custGeom>
            <a:avLst/>
            <a:gdLst/>
            <a:ahLst/>
            <a:rect l="l" t="t" r="r" b="b"/>
            <a:pathLst>
              <a:path w="887" h="912">
                <a:moveTo>
                  <a:pt x="430" y="456"/>
                </a:moveTo>
                <a:lnTo>
                  <a:pt x="0" y="607"/>
                </a:lnTo>
                <a:lnTo>
                  <a:pt x="18" y="650"/>
                </a:lnTo>
                <a:lnTo>
                  <a:pt x="39" y="690"/>
                </a:lnTo>
                <a:lnTo>
                  <a:pt x="64" y="728"/>
                </a:lnTo>
                <a:lnTo>
                  <a:pt x="93" y="762"/>
                </a:lnTo>
                <a:lnTo>
                  <a:pt x="125" y="794"/>
                </a:lnTo>
                <a:lnTo>
                  <a:pt x="158" y="821"/>
                </a:lnTo>
                <a:lnTo>
                  <a:pt x="194" y="846"/>
                </a:lnTo>
                <a:lnTo>
                  <a:pt x="234" y="867"/>
                </a:lnTo>
                <a:lnTo>
                  <a:pt x="274" y="883"/>
                </a:lnTo>
                <a:lnTo>
                  <a:pt x="316" y="896"/>
                </a:lnTo>
                <a:lnTo>
                  <a:pt x="358" y="906"/>
                </a:lnTo>
                <a:lnTo>
                  <a:pt x="403" y="910"/>
                </a:lnTo>
                <a:lnTo>
                  <a:pt x="425" y="912"/>
                </a:lnTo>
                <a:lnTo>
                  <a:pt x="448" y="910"/>
                </a:lnTo>
                <a:lnTo>
                  <a:pt x="470" y="909"/>
                </a:lnTo>
                <a:lnTo>
                  <a:pt x="492" y="907"/>
                </a:lnTo>
                <a:lnTo>
                  <a:pt x="514" y="904"/>
                </a:lnTo>
                <a:lnTo>
                  <a:pt x="537" y="898"/>
                </a:lnTo>
                <a:lnTo>
                  <a:pt x="560" y="893"/>
                </a:lnTo>
                <a:lnTo>
                  <a:pt x="582" y="885"/>
                </a:lnTo>
                <a:lnTo>
                  <a:pt x="626" y="868"/>
                </a:lnTo>
                <a:lnTo>
                  <a:pt x="666" y="846"/>
                </a:lnTo>
                <a:lnTo>
                  <a:pt x="703" y="821"/>
                </a:lnTo>
                <a:lnTo>
                  <a:pt x="737" y="793"/>
                </a:lnTo>
                <a:lnTo>
                  <a:pt x="769" y="761"/>
                </a:lnTo>
                <a:lnTo>
                  <a:pt x="797" y="727"/>
                </a:lnTo>
                <a:lnTo>
                  <a:pt x="821" y="691"/>
                </a:lnTo>
                <a:lnTo>
                  <a:pt x="842" y="652"/>
                </a:lnTo>
                <a:lnTo>
                  <a:pt x="858" y="612"/>
                </a:lnTo>
                <a:lnTo>
                  <a:pt x="871" y="570"/>
                </a:lnTo>
                <a:lnTo>
                  <a:pt x="881" y="528"/>
                </a:lnTo>
                <a:lnTo>
                  <a:pt x="886" y="483"/>
                </a:lnTo>
                <a:lnTo>
                  <a:pt x="887" y="461"/>
                </a:lnTo>
                <a:lnTo>
                  <a:pt x="887" y="439"/>
                </a:lnTo>
                <a:lnTo>
                  <a:pt x="884" y="416"/>
                </a:lnTo>
                <a:lnTo>
                  <a:pt x="882" y="393"/>
                </a:lnTo>
                <a:lnTo>
                  <a:pt x="879" y="372"/>
                </a:lnTo>
                <a:lnTo>
                  <a:pt x="874" y="349"/>
                </a:lnTo>
                <a:lnTo>
                  <a:pt x="868" y="327"/>
                </a:lnTo>
                <a:lnTo>
                  <a:pt x="860" y="304"/>
                </a:lnTo>
                <a:lnTo>
                  <a:pt x="847" y="270"/>
                </a:lnTo>
                <a:lnTo>
                  <a:pt x="832" y="238"/>
                </a:lnTo>
                <a:lnTo>
                  <a:pt x="814" y="208"/>
                </a:lnTo>
                <a:lnTo>
                  <a:pt x="794" y="180"/>
                </a:lnTo>
                <a:lnTo>
                  <a:pt x="771" y="152"/>
                </a:lnTo>
                <a:lnTo>
                  <a:pt x="747" y="127"/>
                </a:lnTo>
                <a:lnTo>
                  <a:pt x="722" y="104"/>
                </a:lnTo>
                <a:lnTo>
                  <a:pt x="693" y="84"/>
                </a:lnTo>
                <a:lnTo>
                  <a:pt x="665" y="65"/>
                </a:lnTo>
                <a:lnTo>
                  <a:pt x="634" y="48"/>
                </a:lnTo>
                <a:lnTo>
                  <a:pt x="603" y="33"/>
                </a:lnTo>
                <a:lnTo>
                  <a:pt x="570" y="21"/>
                </a:lnTo>
                <a:lnTo>
                  <a:pt x="536" y="13"/>
                </a:lnTo>
                <a:lnTo>
                  <a:pt x="502" y="5"/>
                </a:lnTo>
                <a:lnTo>
                  <a:pt x="466" y="2"/>
                </a:lnTo>
                <a:lnTo>
                  <a:pt x="430" y="0"/>
                </a:lnTo>
                <a:lnTo>
                  <a:pt x="430" y="456"/>
                </a:lnTo>
                <a:close/>
              </a:path>
            </a:pathLst>
          </a:custGeom>
          <a:solidFill>
            <a:srgbClr val="ff99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Freeform 174"/>
          <p:cNvSpPr/>
          <p:nvPr/>
        </p:nvSpPr>
        <p:spPr>
          <a:xfrm>
            <a:off x="2500200" y="3605040"/>
            <a:ext cx="362160" cy="281160"/>
          </a:xfrm>
          <a:custGeom>
            <a:avLst/>
            <a:gdLst/>
            <a:ahLst/>
            <a:rect l="l" t="t" r="r" b="b"/>
            <a:pathLst>
              <a:path w="455" h="354">
                <a:moveTo>
                  <a:pt x="455" y="203"/>
                </a:moveTo>
                <a:lnTo>
                  <a:pt x="47" y="0"/>
                </a:lnTo>
                <a:lnTo>
                  <a:pt x="37" y="20"/>
                </a:lnTo>
                <a:lnTo>
                  <a:pt x="28" y="41"/>
                </a:lnTo>
                <a:lnTo>
                  <a:pt x="21" y="63"/>
                </a:lnTo>
                <a:lnTo>
                  <a:pt x="15" y="85"/>
                </a:lnTo>
                <a:lnTo>
                  <a:pt x="10" y="107"/>
                </a:lnTo>
                <a:lnTo>
                  <a:pt x="5" y="129"/>
                </a:lnTo>
                <a:lnTo>
                  <a:pt x="2" y="152"/>
                </a:lnTo>
                <a:lnTo>
                  <a:pt x="0" y="174"/>
                </a:lnTo>
                <a:lnTo>
                  <a:pt x="0" y="197"/>
                </a:lnTo>
                <a:lnTo>
                  <a:pt x="0" y="220"/>
                </a:lnTo>
                <a:lnTo>
                  <a:pt x="1" y="243"/>
                </a:lnTo>
                <a:lnTo>
                  <a:pt x="3" y="265"/>
                </a:lnTo>
                <a:lnTo>
                  <a:pt x="8" y="288"/>
                </a:lnTo>
                <a:lnTo>
                  <a:pt x="12" y="309"/>
                </a:lnTo>
                <a:lnTo>
                  <a:pt x="18" y="332"/>
                </a:lnTo>
                <a:lnTo>
                  <a:pt x="25" y="354"/>
                </a:lnTo>
                <a:lnTo>
                  <a:pt x="455" y="203"/>
                </a:lnTo>
                <a:close/>
              </a:path>
            </a:pathLst>
          </a:custGeom>
          <a:solidFill>
            <a:srgbClr val="0066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Freeform 175"/>
          <p:cNvSpPr/>
          <p:nvPr/>
        </p:nvSpPr>
        <p:spPr>
          <a:xfrm>
            <a:off x="2536920" y="3498840"/>
            <a:ext cx="325440" cy="266760"/>
          </a:xfrm>
          <a:custGeom>
            <a:avLst/>
            <a:gdLst/>
            <a:ahLst/>
            <a:rect l="l" t="t" r="r" b="b"/>
            <a:pathLst>
              <a:path w="408" h="338">
                <a:moveTo>
                  <a:pt x="408" y="338"/>
                </a:moveTo>
                <a:lnTo>
                  <a:pt x="101" y="0"/>
                </a:lnTo>
                <a:lnTo>
                  <a:pt x="71" y="31"/>
                </a:lnTo>
                <a:lnTo>
                  <a:pt x="45" y="63"/>
                </a:lnTo>
                <a:lnTo>
                  <a:pt x="21" y="98"/>
                </a:lnTo>
                <a:lnTo>
                  <a:pt x="0" y="135"/>
                </a:lnTo>
                <a:lnTo>
                  <a:pt x="408" y="338"/>
                </a:lnTo>
                <a:close/>
              </a:path>
            </a:pathLst>
          </a:custGeom>
          <a:solidFill>
            <a:srgbClr val="0070c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Freeform 176"/>
          <p:cNvSpPr/>
          <p:nvPr/>
        </p:nvSpPr>
        <p:spPr>
          <a:xfrm>
            <a:off x="2617920" y="3403440"/>
            <a:ext cx="244440" cy="362160"/>
          </a:xfrm>
          <a:custGeom>
            <a:avLst/>
            <a:gdLst/>
            <a:ahLst/>
            <a:rect l="l" t="t" r="r" b="b"/>
            <a:pathLst>
              <a:path w="307" h="456">
                <a:moveTo>
                  <a:pt x="307" y="456"/>
                </a:moveTo>
                <a:lnTo>
                  <a:pt x="307" y="0"/>
                </a:lnTo>
                <a:lnTo>
                  <a:pt x="265" y="2"/>
                </a:lnTo>
                <a:lnTo>
                  <a:pt x="223" y="7"/>
                </a:lnTo>
                <a:lnTo>
                  <a:pt x="183" y="17"/>
                </a:lnTo>
                <a:lnTo>
                  <a:pt x="142" y="30"/>
                </a:lnTo>
                <a:lnTo>
                  <a:pt x="104" y="48"/>
                </a:lnTo>
                <a:lnTo>
                  <a:pt x="68" y="68"/>
                </a:lnTo>
                <a:lnTo>
                  <a:pt x="33" y="91"/>
                </a:lnTo>
                <a:lnTo>
                  <a:pt x="0" y="118"/>
                </a:lnTo>
                <a:lnTo>
                  <a:pt x="307" y="456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737"/>
          <p:cNvSpPr/>
          <p:nvPr/>
        </p:nvSpPr>
        <p:spPr>
          <a:xfrm>
            <a:off x="2788920" y="3794040"/>
            <a:ext cx="392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71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  <a:ea typeface="Arial"/>
              </a:rPr>
              <a:t>±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1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737"/>
          <p:cNvSpPr/>
          <p:nvPr/>
        </p:nvSpPr>
        <p:spPr>
          <a:xfrm>
            <a:off x="2446920" y="3675240"/>
            <a:ext cx="392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13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  <a:ea typeface="Arial"/>
              </a:rPr>
              <a:t>±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1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737"/>
          <p:cNvSpPr/>
          <p:nvPr/>
        </p:nvSpPr>
        <p:spPr>
          <a:xfrm rot="1641000">
            <a:off x="2494080" y="3517560"/>
            <a:ext cx="307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Arial"/>
              </a:rPr>
              <a:t>6</a:t>
            </a:r>
            <a:r>
              <a:rPr b="0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±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737"/>
          <p:cNvSpPr/>
          <p:nvPr/>
        </p:nvSpPr>
        <p:spPr>
          <a:xfrm rot="2848800">
            <a:off x="2603520" y="3436920"/>
            <a:ext cx="3499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Arial"/>
              </a:rPr>
              <a:t>12</a:t>
            </a:r>
            <a:r>
              <a:rPr b="0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±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Freeform 139"/>
          <p:cNvSpPr/>
          <p:nvPr/>
        </p:nvSpPr>
        <p:spPr>
          <a:xfrm>
            <a:off x="2496960" y="1751040"/>
            <a:ext cx="725760" cy="723960"/>
          </a:xfrm>
          <a:custGeom>
            <a:avLst/>
            <a:gdLst/>
            <a:ahLst/>
            <a:rect l="l" t="t" r="r" b="b"/>
            <a:pathLst>
              <a:path w="1370" h="1368">
                <a:moveTo>
                  <a:pt x="684" y="685"/>
                </a:moveTo>
                <a:lnTo>
                  <a:pt x="2" y="631"/>
                </a:lnTo>
                <a:lnTo>
                  <a:pt x="0" y="666"/>
                </a:lnTo>
                <a:lnTo>
                  <a:pt x="0" y="702"/>
                </a:lnTo>
                <a:lnTo>
                  <a:pt x="1" y="736"/>
                </a:lnTo>
                <a:lnTo>
                  <a:pt x="5" y="770"/>
                </a:lnTo>
                <a:lnTo>
                  <a:pt x="10" y="803"/>
                </a:lnTo>
                <a:lnTo>
                  <a:pt x="17" y="836"/>
                </a:lnTo>
                <a:lnTo>
                  <a:pt x="26" y="869"/>
                </a:lnTo>
                <a:lnTo>
                  <a:pt x="35" y="900"/>
                </a:lnTo>
                <a:lnTo>
                  <a:pt x="46" y="932"/>
                </a:lnTo>
                <a:lnTo>
                  <a:pt x="58" y="962"/>
                </a:lnTo>
                <a:lnTo>
                  <a:pt x="73" y="993"/>
                </a:lnTo>
                <a:lnTo>
                  <a:pt x="89" y="1021"/>
                </a:lnTo>
                <a:lnTo>
                  <a:pt x="106" y="1050"/>
                </a:lnTo>
                <a:lnTo>
                  <a:pt x="124" y="1077"/>
                </a:lnTo>
                <a:lnTo>
                  <a:pt x="144" y="1104"/>
                </a:lnTo>
                <a:lnTo>
                  <a:pt x="165" y="1129"/>
                </a:lnTo>
                <a:lnTo>
                  <a:pt x="210" y="1177"/>
                </a:lnTo>
                <a:lnTo>
                  <a:pt x="259" y="1220"/>
                </a:lnTo>
                <a:lnTo>
                  <a:pt x="285" y="1240"/>
                </a:lnTo>
                <a:lnTo>
                  <a:pt x="312" y="1259"/>
                </a:lnTo>
                <a:lnTo>
                  <a:pt x="340" y="1276"/>
                </a:lnTo>
                <a:lnTo>
                  <a:pt x="370" y="1291"/>
                </a:lnTo>
                <a:lnTo>
                  <a:pt x="400" y="1306"/>
                </a:lnTo>
                <a:lnTo>
                  <a:pt x="431" y="1319"/>
                </a:lnTo>
                <a:lnTo>
                  <a:pt x="462" y="1332"/>
                </a:lnTo>
                <a:lnTo>
                  <a:pt x="495" y="1341"/>
                </a:lnTo>
                <a:lnTo>
                  <a:pt x="528" y="1350"/>
                </a:lnTo>
                <a:lnTo>
                  <a:pt x="562" y="1357"/>
                </a:lnTo>
                <a:lnTo>
                  <a:pt x="596" y="1362"/>
                </a:lnTo>
                <a:lnTo>
                  <a:pt x="632" y="1366"/>
                </a:lnTo>
                <a:lnTo>
                  <a:pt x="667" y="1368"/>
                </a:lnTo>
                <a:lnTo>
                  <a:pt x="701" y="1368"/>
                </a:lnTo>
                <a:lnTo>
                  <a:pt x="737" y="1367"/>
                </a:lnTo>
                <a:lnTo>
                  <a:pt x="770" y="1363"/>
                </a:lnTo>
                <a:lnTo>
                  <a:pt x="804" y="1358"/>
                </a:lnTo>
                <a:lnTo>
                  <a:pt x="837" y="1351"/>
                </a:lnTo>
                <a:lnTo>
                  <a:pt x="870" y="1343"/>
                </a:lnTo>
                <a:lnTo>
                  <a:pt x="901" y="1333"/>
                </a:lnTo>
                <a:lnTo>
                  <a:pt x="933" y="1322"/>
                </a:lnTo>
                <a:lnTo>
                  <a:pt x="964" y="1310"/>
                </a:lnTo>
                <a:lnTo>
                  <a:pt x="993" y="1295"/>
                </a:lnTo>
                <a:lnTo>
                  <a:pt x="1022" y="1279"/>
                </a:lnTo>
                <a:lnTo>
                  <a:pt x="1050" y="1262"/>
                </a:lnTo>
                <a:lnTo>
                  <a:pt x="1078" y="1244"/>
                </a:lnTo>
                <a:lnTo>
                  <a:pt x="1105" y="1224"/>
                </a:lnTo>
                <a:lnTo>
                  <a:pt x="1130" y="1204"/>
                </a:lnTo>
                <a:lnTo>
                  <a:pt x="1178" y="1159"/>
                </a:lnTo>
                <a:lnTo>
                  <a:pt x="1221" y="1110"/>
                </a:lnTo>
                <a:lnTo>
                  <a:pt x="1242" y="1083"/>
                </a:lnTo>
                <a:lnTo>
                  <a:pt x="1260" y="1056"/>
                </a:lnTo>
                <a:lnTo>
                  <a:pt x="1277" y="1028"/>
                </a:lnTo>
                <a:lnTo>
                  <a:pt x="1293" y="999"/>
                </a:lnTo>
                <a:lnTo>
                  <a:pt x="1308" y="968"/>
                </a:lnTo>
                <a:lnTo>
                  <a:pt x="1321" y="938"/>
                </a:lnTo>
                <a:lnTo>
                  <a:pt x="1333" y="906"/>
                </a:lnTo>
                <a:lnTo>
                  <a:pt x="1343" y="873"/>
                </a:lnTo>
                <a:lnTo>
                  <a:pt x="1352" y="841"/>
                </a:lnTo>
                <a:lnTo>
                  <a:pt x="1359" y="806"/>
                </a:lnTo>
                <a:lnTo>
                  <a:pt x="1364" y="772"/>
                </a:lnTo>
                <a:lnTo>
                  <a:pt x="1367" y="737"/>
                </a:lnTo>
                <a:lnTo>
                  <a:pt x="1370" y="702"/>
                </a:lnTo>
                <a:lnTo>
                  <a:pt x="1370" y="667"/>
                </a:lnTo>
                <a:lnTo>
                  <a:pt x="1367" y="633"/>
                </a:lnTo>
                <a:lnTo>
                  <a:pt x="1365" y="599"/>
                </a:lnTo>
                <a:lnTo>
                  <a:pt x="1359" y="565"/>
                </a:lnTo>
                <a:lnTo>
                  <a:pt x="1353" y="532"/>
                </a:lnTo>
                <a:lnTo>
                  <a:pt x="1344" y="499"/>
                </a:lnTo>
                <a:lnTo>
                  <a:pt x="1334" y="468"/>
                </a:lnTo>
                <a:lnTo>
                  <a:pt x="1323" y="436"/>
                </a:lnTo>
                <a:lnTo>
                  <a:pt x="1310" y="405"/>
                </a:lnTo>
                <a:lnTo>
                  <a:pt x="1297" y="376"/>
                </a:lnTo>
                <a:lnTo>
                  <a:pt x="1281" y="347"/>
                </a:lnTo>
                <a:lnTo>
                  <a:pt x="1264" y="319"/>
                </a:lnTo>
                <a:lnTo>
                  <a:pt x="1245" y="291"/>
                </a:lnTo>
                <a:lnTo>
                  <a:pt x="1226" y="265"/>
                </a:lnTo>
                <a:lnTo>
                  <a:pt x="1205" y="240"/>
                </a:lnTo>
                <a:lnTo>
                  <a:pt x="1160" y="191"/>
                </a:lnTo>
                <a:lnTo>
                  <a:pt x="1111" y="148"/>
                </a:lnTo>
                <a:lnTo>
                  <a:pt x="1084" y="129"/>
                </a:lnTo>
                <a:lnTo>
                  <a:pt x="1058" y="109"/>
                </a:lnTo>
                <a:lnTo>
                  <a:pt x="1028" y="92"/>
                </a:lnTo>
                <a:lnTo>
                  <a:pt x="999" y="76"/>
                </a:lnTo>
                <a:lnTo>
                  <a:pt x="970" y="62"/>
                </a:lnTo>
                <a:lnTo>
                  <a:pt x="939" y="48"/>
                </a:lnTo>
                <a:lnTo>
                  <a:pt x="908" y="36"/>
                </a:lnTo>
                <a:lnTo>
                  <a:pt x="875" y="26"/>
                </a:lnTo>
                <a:lnTo>
                  <a:pt x="842" y="18"/>
                </a:lnTo>
                <a:lnTo>
                  <a:pt x="807" y="11"/>
                </a:lnTo>
                <a:lnTo>
                  <a:pt x="773" y="6"/>
                </a:lnTo>
                <a:lnTo>
                  <a:pt x="738" y="2"/>
                </a:lnTo>
                <a:lnTo>
                  <a:pt x="684" y="0"/>
                </a:lnTo>
                <a:lnTo>
                  <a:pt x="684" y="685"/>
                </a:lnTo>
                <a:close/>
              </a:path>
            </a:pathLst>
          </a:custGeom>
          <a:solidFill>
            <a:srgbClr val="ff99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Freeform 140"/>
          <p:cNvSpPr/>
          <p:nvPr/>
        </p:nvSpPr>
        <p:spPr>
          <a:xfrm>
            <a:off x="2498760" y="2041560"/>
            <a:ext cx="360360" cy="73080"/>
          </a:xfrm>
          <a:custGeom>
            <a:avLst/>
            <a:gdLst/>
            <a:ahLst/>
            <a:rect l="l" t="t" r="r" b="b"/>
            <a:pathLst>
              <a:path w="682" h="138">
                <a:moveTo>
                  <a:pt x="682" y="138"/>
                </a:moveTo>
                <a:lnTo>
                  <a:pt x="11" y="0"/>
                </a:lnTo>
                <a:lnTo>
                  <a:pt x="4" y="41"/>
                </a:lnTo>
                <a:lnTo>
                  <a:pt x="0" y="84"/>
                </a:lnTo>
                <a:lnTo>
                  <a:pt x="682" y="138"/>
                </a:lnTo>
                <a:close/>
              </a:path>
            </a:pathLst>
          </a:custGeom>
          <a:solidFill>
            <a:srgbClr val="0066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Freeform 141"/>
          <p:cNvSpPr/>
          <p:nvPr/>
        </p:nvSpPr>
        <p:spPr>
          <a:xfrm>
            <a:off x="2505240" y="1833480"/>
            <a:ext cx="353880" cy="281160"/>
          </a:xfrm>
          <a:custGeom>
            <a:avLst/>
            <a:gdLst/>
            <a:ahLst/>
            <a:rect l="l" t="t" r="r" b="b"/>
            <a:pathLst>
              <a:path w="671" h="531">
                <a:moveTo>
                  <a:pt x="671" y="531"/>
                </a:moveTo>
                <a:lnTo>
                  <a:pt x="238" y="0"/>
                </a:lnTo>
                <a:lnTo>
                  <a:pt x="194" y="39"/>
                </a:lnTo>
                <a:lnTo>
                  <a:pt x="154" y="82"/>
                </a:lnTo>
                <a:lnTo>
                  <a:pt x="119" y="127"/>
                </a:lnTo>
                <a:lnTo>
                  <a:pt x="86" y="176"/>
                </a:lnTo>
                <a:lnTo>
                  <a:pt x="58" y="227"/>
                </a:lnTo>
                <a:lnTo>
                  <a:pt x="34" y="281"/>
                </a:lnTo>
                <a:lnTo>
                  <a:pt x="15" y="336"/>
                </a:lnTo>
                <a:lnTo>
                  <a:pt x="8" y="364"/>
                </a:lnTo>
                <a:lnTo>
                  <a:pt x="0" y="393"/>
                </a:lnTo>
                <a:lnTo>
                  <a:pt x="671" y="531"/>
                </a:lnTo>
                <a:close/>
              </a:path>
            </a:pathLst>
          </a:custGeom>
          <a:solidFill>
            <a:srgbClr val="0070c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Freeform 142"/>
          <p:cNvSpPr/>
          <p:nvPr/>
        </p:nvSpPr>
        <p:spPr>
          <a:xfrm>
            <a:off x="2630520" y="1751040"/>
            <a:ext cx="228600" cy="363600"/>
          </a:xfrm>
          <a:custGeom>
            <a:avLst/>
            <a:gdLst/>
            <a:ahLst/>
            <a:rect l="l" t="t" r="r" b="b"/>
            <a:pathLst>
              <a:path w="433" h="685">
                <a:moveTo>
                  <a:pt x="433" y="685"/>
                </a:moveTo>
                <a:lnTo>
                  <a:pt x="433" y="0"/>
                </a:lnTo>
                <a:lnTo>
                  <a:pt x="404" y="1"/>
                </a:lnTo>
                <a:lnTo>
                  <a:pt x="375" y="2"/>
                </a:lnTo>
                <a:lnTo>
                  <a:pt x="345" y="6"/>
                </a:lnTo>
                <a:lnTo>
                  <a:pt x="316" y="9"/>
                </a:lnTo>
                <a:lnTo>
                  <a:pt x="288" y="15"/>
                </a:lnTo>
                <a:lnTo>
                  <a:pt x="260" y="23"/>
                </a:lnTo>
                <a:lnTo>
                  <a:pt x="204" y="40"/>
                </a:lnTo>
                <a:lnTo>
                  <a:pt x="150" y="62"/>
                </a:lnTo>
                <a:lnTo>
                  <a:pt x="98" y="87"/>
                </a:lnTo>
                <a:lnTo>
                  <a:pt x="48" y="119"/>
                </a:lnTo>
                <a:lnTo>
                  <a:pt x="0" y="154"/>
                </a:lnTo>
                <a:lnTo>
                  <a:pt x="433" y="685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737"/>
          <p:cNvSpPr/>
          <p:nvPr/>
        </p:nvSpPr>
        <p:spPr>
          <a:xfrm>
            <a:off x="2777760" y="2135160"/>
            <a:ext cx="392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77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  <a:ea typeface="Arial"/>
              </a:rPr>
              <a:t>±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2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737"/>
          <p:cNvSpPr/>
          <p:nvPr/>
        </p:nvSpPr>
        <p:spPr>
          <a:xfrm>
            <a:off x="2437920" y="1976400"/>
            <a:ext cx="307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2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  <a:ea typeface="Arial"/>
              </a:rPr>
              <a:t>±</a:t>
            </a:r>
            <a:r>
              <a:rPr b="0" lang="de-DE" sz="600" spc="-1" strike="noStrike">
                <a:solidFill>
                  <a:srgbClr val="ffffff"/>
                </a:solidFill>
                <a:latin typeface="Arial"/>
              </a:rPr>
              <a:t>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737"/>
          <p:cNvSpPr/>
          <p:nvPr/>
        </p:nvSpPr>
        <p:spPr>
          <a:xfrm rot="1407000">
            <a:off x="2453040" y="1895040"/>
            <a:ext cx="392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Arial"/>
              </a:rPr>
              <a:t>11</a:t>
            </a:r>
            <a:r>
              <a:rPr b="0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±1</a:t>
            </a:r>
            <a:r>
              <a:rPr b="0" lang="de-DE" sz="6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737"/>
          <p:cNvSpPr/>
          <p:nvPr/>
        </p:nvSpPr>
        <p:spPr>
          <a:xfrm rot="3718800">
            <a:off x="2595960" y="1798200"/>
            <a:ext cx="3499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Arial"/>
              </a:rPr>
              <a:t>11</a:t>
            </a:r>
            <a:r>
              <a:rPr b="0" lang="de-DE" sz="600" spc="-1" strike="noStrike">
                <a:solidFill>
                  <a:srgbClr val="000000"/>
                </a:solidFill>
                <a:latin typeface="Arial"/>
                <a:ea typeface="Arial"/>
              </a:rPr>
              <a:t>±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2-25T14:58:13Z</dcterms:created>
  <dc:creator>grass</dc:creator>
  <dc:description/>
  <dc:language>en-US</dc:language>
  <cp:lastModifiedBy>schnuffel</cp:lastModifiedBy>
  <cp:lastPrinted>2014-09-22T20:34:08Z</cp:lastPrinted>
  <dcterms:modified xsi:type="dcterms:W3CDTF">2017-02-06T13:03:05Z</dcterms:modified>
  <cp:revision>112</cp:revision>
  <dc:subject/>
  <dc:title>Folie 1</dc:title>
</cp:coreProperties>
</file>